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60" r:id="rId4"/>
  </p:sldMasterIdLst>
  <p:notesMasterIdLst>
    <p:notesMasterId r:id="rId6"/>
  </p:notesMasterIdLst>
  <p:sldIdLst>
    <p:sldId id="446" r:id="rId5"/>
  </p:sldIdLst>
  <p:sldSz cx="7772400" cy="10058400"/>
  <p:notesSz cx="6858000" cy="931386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" userDrawn="1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6068DBE-86C7-4304-ED7F-2A9F08DD3959}" name="Wu, Xinran" initials="XW" userId="S::xfw5168@psu.edu::4bb7de01-25b2-4c43-a716-f88bd92282df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n, Ying" initials="PY" lastIdx="1" clrIdx="0">
    <p:extLst>
      <p:ext uri="{19B8F6BF-5375-455C-9EA6-DF929625EA0E}">
        <p15:presenceInfo xmlns:p15="http://schemas.microsoft.com/office/powerpoint/2012/main" userId="S-1-5-21-2495596442-1611635750-2694579155-191922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FF5"/>
    <a:srgbClr val="F2E1D2"/>
    <a:srgbClr val="BF9000"/>
    <a:srgbClr val="FBFBFB"/>
    <a:srgbClr val="02AE02"/>
    <a:srgbClr val="4588EB"/>
    <a:srgbClr val="ECBADA"/>
    <a:srgbClr val="FFF6EC"/>
    <a:srgbClr val="E6E6E6"/>
    <a:srgbClr val="FFEE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256" autoAdjust="0"/>
    <p:restoredTop sz="96247" autoAdjust="0"/>
  </p:normalViewPr>
  <p:slideViewPr>
    <p:cSldViewPr snapToGrid="0">
      <p:cViewPr varScale="1">
        <p:scale>
          <a:sx n="54" d="100"/>
          <a:sy n="54" d="100"/>
        </p:scale>
        <p:origin x="2462" y="72"/>
      </p:cViewPr>
      <p:guideLst>
        <p:guide orient="horz" pos="144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67311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1"/>
            <a:ext cx="2971800" cy="467311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EB78185C-859B-40BC-ABA3-B139E2957FF5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163638"/>
            <a:ext cx="2428875" cy="31448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82298"/>
            <a:ext cx="5486400" cy="36673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5"/>
            <a:ext cx="2971800" cy="467310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46555"/>
            <a:ext cx="2971800" cy="467310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8163C338-7EAE-423D-8AB2-ACD8A66746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6775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D7AA35-6F2C-41E2-90C6-FFA5FE5F01E5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C24E4A-2C4F-4032-BAC1-1871B64E1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33C2B8-ED74-43E4-AC19-FBEB6E909DA8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EA3C1E-045C-43E0-98A6-97050B94906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E815B0-3584-4F20-934B-7D03DD51F1C5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2AF47E-7083-4114-A623-1B5A444CC3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DEDD05-3299-484C-AFDD-F216E25F75A7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9C7E7F-9F41-487D-AB0C-993686EFB0F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5B3EA7-A6AE-4DF0-B9EE-A5602878C09C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46DA2F-77B9-40E1-A4DD-B0C7910FA7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59F40B-9155-4B1C-BA9F-72B9D56D5B64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B0A84D-E666-4F7C-9F4C-3951720E4A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6D9052-F4B4-4BED-A960-501D702DA74E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9E8D20-456D-49AC-8872-EF24F058D11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0D1A93-D31B-4AD4-8C21-7C876AE1782B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8ED06-7BDD-401F-B82B-48B1193A2BA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62DFD-0052-430E-875D-014143EABBA6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1F1FEF-06F4-4673-A27C-099A04E700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E9B0D9-053A-4265-BC3F-742361307D52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7B4CDD-083F-48B6-913F-4953183D579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rtlCol="0">
            <a:normAutofit/>
          </a:bodyPr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pPr lvl="0"/>
            <a:r>
              <a:rPr lang="en-US" noProof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81F34E-0C66-4ED1-AD48-F823205FC41C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C9DF67-A35B-4832-A8BA-3E72DFF2390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Title Placeholder 1"/>
          <p:cNvSpPr>
            <a:spLocks noGrp="1"/>
          </p:cNvSpPr>
          <p:nvPr>
            <p:ph type="title"/>
          </p:nvPr>
        </p:nvSpPr>
        <p:spPr bwMode="auto">
          <a:xfrm>
            <a:off x="534988" y="534988"/>
            <a:ext cx="6702425" cy="1944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1843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534988" y="2678113"/>
            <a:ext cx="6702425" cy="6381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988" y="9323388"/>
            <a:ext cx="1747837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E97FA4F-72E2-41C2-B65A-832381094F6B}" type="datetimeFigureOut">
              <a:rPr lang="en-US"/>
              <a:pPr>
                <a:defRPr/>
              </a:pPr>
              <a:t>5/29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925" y="9323388"/>
            <a:ext cx="2622550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575" y="9323388"/>
            <a:ext cx="1747838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C86C926-6C46-4BAB-9CE6-FDFEB84D22C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2pPr>
      <a:lvl3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3pPr>
      <a:lvl4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4pPr>
      <a:lvl5pPr algn="l" defTabSz="776288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5pPr>
      <a:lvl6pPr marL="4572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6pPr>
      <a:lvl7pPr marL="9144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7pPr>
      <a:lvl8pPr marL="13716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8pPr>
      <a:lvl9pPr marL="18288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/>
        </a:defRPr>
      </a:lvl9pPr>
    </p:titleStyle>
    <p:bodyStyle>
      <a:lvl1pPr marL="193675" indent="-193675" algn="l" defTabSz="776288" rtl="0" eaLnBrk="0" fontAlgn="base" hangingPunct="0">
        <a:lnSpc>
          <a:spcPct val="90000"/>
        </a:lnSpc>
        <a:spcBef>
          <a:spcPts val="850"/>
        </a:spcBef>
        <a:spcAft>
          <a:spcPct val="0"/>
        </a:spcAft>
        <a:buFont typeface="Arial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82613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58900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47838" indent="-193675" algn="l" defTabSz="776288" rtl="0" eaLnBrk="0" fontAlgn="base" hangingPunct="0">
        <a:lnSpc>
          <a:spcPct val="90000"/>
        </a:lnSpc>
        <a:spcBef>
          <a:spcPts val="42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measuring device&#10;&#10;AI-generated content may be incorrect.">
            <a:extLst>
              <a:ext uri="{FF2B5EF4-FFF2-40B4-BE49-F238E27FC236}">
                <a16:creationId xmlns:a16="http://schemas.microsoft.com/office/drawing/2014/main" id="{E0D15302-48DC-AD8F-33FC-4C12C2F6890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408" r="20178"/>
          <a:stretch/>
        </p:blipFill>
        <p:spPr>
          <a:xfrm>
            <a:off x="731760" y="736408"/>
            <a:ext cx="3191952" cy="3659699"/>
          </a:xfrm>
          <a:prstGeom prst="rect">
            <a:avLst/>
          </a:prstGeom>
        </p:spPr>
      </p:pic>
      <p:pic>
        <p:nvPicPr>
          <p:cNvPr id="35" name="Picture 34" descr="A close-up of a laboratory equipment&#10;&#10;AI-generated content may be incorrect.">
            <a:extLst>
              <a:ext uri="{FF2B5EF4-FFF2-40B4-BE49-F238E27FC236}">
                <a16:creationId xmlns:a16="http://schemas.microsoft.com/office/drawing/2014/main" id="{3F258B5E-95E6-8B47-3390-466B6949D29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9285" t="38573" r="38907" b="27237"/>
          <a:stretch/>
        </p:blipFill>
        <p:spPr>
          <a:xfrm>
            <a:off x="4328736" y="736408"/>
            <a:ext cx="2253499" cy="3670465"/>
          </a:xfrm>
          <a:prstGeom prst="rect">
            <a:avLst/>
          </a:prstGeom>
        </p:spPr>
      </p:pic>
      <p:pic>
        <p:nvPicPr>
          <p:cNvPr id="5" name="Picture 4" descr="Diagram of a cell solution in a container&#10;&#10;AI-generated content may be incorrect.">
            <a:extLst>
              <a:ext uri="{FF2B5EF4-FFF2-40B4-BE49-F238E27FC236}">
                <a16:creationId xmlns:a16="http://schemas.microsoft.com/office/drawing/2014/main" id="{AA7E6669-E9C3-2A4F-5A04-1034219BC23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42" r="22590"/>
          <a:stretch>
            <a:fillRect/>
          </a:stretch>
        </p:blipFill>
        <p:spPr>
          <a:xfrm>
            <a:off x="669122" y="4804174"/>
            <a:ext cx="3356191" cy="353400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4A6BD28-DCE4-CD6F-BDDE-99A7892872F4}"/>
              </a:ext>
            </a:extLst>
          </p:cNvPr>
          <p:cNvSpPr txBox="1"/>
          <p:nvPr/>
        </p:nvSpPr>
        <p:spPr>
          <a:xfrm>
            <a:off x="762554" y="1704827"/>
            <a:ext cx="719316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ic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BED4C3BD-D514-79E7-5573-8C5A4AF2F779}"/>
              </a:ext>
            </a:extLst>
          </p:cNvPr>
          <p:cNvCxnSpPr>
            <a:cxnSpLocks/>
          </p:cNvCxnSpPr>
          <p:nvPr/>
        </p:nvCxnSpPr>
        <p:spPr>
          <a:xfrm>
            <a:off x="1122212" y="1981825"/>
            <a:ext cx="0" cy="2319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729D7A1-BAC1-1191-37AA-0FD96DBAE425}"/>
              </a:ext>
            </a:extLst>
          </p:cNvPr>
          <p:cNvSpPr txBox="1"/>
          <p:nvPr/>
        </p:nvSpPr>
        <p:spPr>
          <a:xfrm>
            <a:off x="1660895" y="2547593"/>
            <a:ext cx="10268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llagen solution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4671C15-24EE-E512-EFBE-CC44B08BC8E4}"/>
              </a:ext>
            </a:extLst>
          </p:cNvPr>
          <p:cNvCxnSpPr>
            <a:cxnSpLocks/>
          </p:cNvCxnSpPr>
          <p:nvPr/>
        </p:nvCxnSpPr>
        <p:spPr>
          <a:xfrm>
            <a:off x="3067981" y="1700967"/>
            <a:ext cx="0" cy="3415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D175AE8A-DFBC-A442-59A2-181B308F4C64}"/>
              </a:ext>
            </a:extLst>
          </p:cNvPr>
          <p:cNvSpPr txBox="1"/>
          <p:nvPr/>
        </p:nvSpPr>
        <p:spPr>
          <a:xfrm>
            <a:off x="2942413" y="1636152"/>
            <a:ext cx="879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ell solution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D648F60C-19B2-8AB9-FC20-0054A2CB51A5}"/>
              </a:ext>
            </a:extLst>
          </p:cNvPr>
          <p:cNvCxnSpPr>
            <a:cxnSpLocks/>
          </p:cNvCxnSpPr>
          <p:nvPr/>
        </p:nvCxnSpPr>
        <p:spPr>
          <a:xfrm>
            <a:off x="2040709" y="2566257"/>
            <a:ext cx="30650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FF18C47-803F-B501-24F1-F6DE78A1E9CF}"/>
              </a:ext>
            </a:extLst>
          </p:cNvPr>
          <p:cNvCxnSpPr>
            <a:cxnSpLocks/>
          </p:cNvCxnSpPr>
          <p:nvPr/>
        </p:nvCxnSpPr>
        <p:spPr>
          <a:xfrm flipH="1">
            <a:off x="3256513" y="2373543"/>
            <a:ext cx="24676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2E139EF0-3643-8188-78B3-67312A6B9C17}"/>
              </a:ext>
            </a:extLst>
          </p:cNvPr>
          <p:cNvSpPr/>
          <p:nvPr/>
        </p:nvSpPr>
        <p:spPr>
          <a:xfrm>
            <a:off x="2702151" y="2143036"/>
            <a:ext cx="724278" cy="1647627"/>
          </a:xfrm>
          <a:prstGeom prst="rect">
            <a:avLst/>
          </a:pr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7236F5-20B2-F8A1-F869-DBE15709836A}"/>
              </a:ext>
            </a:extLst>
          </p:cNvPr>
          <p:cNvSpPr txBox="1"/>
          <p:nvPr/>
        </p:nvSpPr>
        <p:spPr>
          <a:xfrm>
            <a:off x="2951639" y="2418763"/>
            <a:ext cx="879814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HEPES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07A238FD-D853-D3FF-CF76-546F08D7E5DC}"/>
              </a:ext>
            </a:extLst>
          </p:cNvPr>
          <p:cNvCxnSpPr>
            <a:cxnSpLocks/>
          </p:cNvCxnSpPr>
          <p:nvPr/>
        </p:nvCxnSpPr>
        <p:spPr>
          <a:xfrm flipV="1">
            <a:off x="3443665" y="747174"/>
            <a:ext cx="885071" cy="1385096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8360E51D-9D13-2741-A3FE-AC0478B6CE61}"/>
              </a:ext>
            </a:extLst>
          </p:cNvPr>
          <p:cNvCxnSpPr>
            <a:cxnSpLocks/>
          </p:cNvCxnSpPr>
          <p:nvPr/>
        </p:nvCxnSpPr>
        <p:spPr>
          <a:xfrm>
            <a:off x="3426429" y="3790663"/>
            <a:ext cx="902307" cy="616210"/>
          </a:xfrm>
          <a:prstGeom prst="line">
            <a:avLst/>
          </a:prstGeom>
          <a:ln w="6350">
            <a:solidFill>
              <a:schemeClr val="tx1"/>
            </a:solidFill>
            <a:prstDash val="dash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BE737BA-81E8-0E77-A204-9336CB9B7AD1}"/>
              </a:ext>
            </a:extLst>
          </p:cNvPr>
          <p:cNvSpPr txBox="1"/>
          <p:nvPr/>
        </p:nvSpPr>
        <p:spPr>
          <a:xfrm>
            <a:off x="5551207" y="697764"/>
            <a:ext cx="879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cell solution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EB26BCA2-D442-3FA5-E525-A9708D18FF6B}"/>
              </a:ext>
            </a:extLst>
          </p:cNvPr>
          <p:cNvCxnSpPr>
            <a:cxnSpLocks/>
          </p:cNvCxnSpPr>
          <p:nvPr/>
        </p:nvCxnSpPr>
        <p:spPr>
          <a:xfrm>
            <a:off x="5607462" y="747174"/>
            <a:ext cx="0" cy="341584"/>
          </a:xfrm>
          <a:prstGeom prst="straightConnector1">
            <a:avLst/>
          </a:prstGeom>
          <a:ln w="6350"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5C116F24-9136-8A0A-4B3E-4C7034EC1EDE}"/>
              </a:ext>
            </a:extLst>
          </p:cNvPr>
          <p:cNvSpPr txBox="1"/>
          <p:nvPr/>
        </p:nvSpPr>
        <p:spPr>
          <a:xfrm>
            <a:off x="4241497" y="1173516"/>
            <a:ext cx="10950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collagen solution (pH=3.0)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0ED51DB0-8389-F869-FC11-D4FB7E767ED7}"/>
              </a:ext>
            </a:extLst>
          </p:cNvPr>
          <p:cNvCxnSpPr>
            <a:cxnSpLocks/>
          </p:cNvCxnSpPr>
          <p:nvPr/>
        </p:nvCxnSpPr>
        <p:spPr>
          <a:xfrm>
            <a:off x="4599196" y="1159429"/>
            <a:ext cx="583684" cy="0"/>
          </a:xfrm>
          <a:prstGeom prst="straightConnector1">
            <a:avLst/>
          </a:prstGeom>
          <a:ln w="6350"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7CA8D10-902D-B4F7-BC1D-A53657B95AE7}"/>
              </a:ext>
            </a:extLst>
          </p:cNvPr>
          <p:cNvCxnSpPr>
            <a:cxnSpLocks/>
          </p:cNvCxnSpPr>
          <p:nvPr/>
        </p:nvCxnSpPr>
        <p:spPr>
          <a:xfrm flipH="1">
            <a:off x="5646592" y="1431872"/>
            <a:ext cx="395039" cy="0"/>
          </a:xfrm>
          <a:prstGeom prst="straightConnector1">
            <a:avLst/>
          </a:prstGeom>
          <a:ln w="6350">
            <a:solidFill>
              <a:schemeClr val="bg1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6AC3B85-D3B3-D700-54B6-965FED6DC4C7}"/>
              </a:ext>
            </a:extLst>
          </p:cNvPr>
          <p:cNvSpPr txBox="1"/>
          <p:nvPr/>
        </p:nvSpPr>
        <p:spPr>
          <a:xfrm>
            <a:off x="5476939" y="1441452"/>
            <a:ext cx="87981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HEPES (pH=7.4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B4D48BF-B7F3-8232-F04C-E593F67461E5}"/>
              </a:ext>
            </a:extLst>
          </p:cNvPr>
          <p:cNvSpPr txBox="1"/>
          <p:nvPr/>
        </p:nvSpPr>
        <p:spPr>
          <a:xfrm>
            <a:off x="4464316" y="3297636"/>
            <a:ext cx="1592709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ysClr val="windowText" lastClr="00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HEPES buffer (pH 7.4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831DCA3-090D-7BA6-AFB6-7D733F1C12B6}"/>
              </a:ext>
            </a:extLst>
          </p:cNvPr>
          <p:cNvSpPr txBox="1"/>
          <p:nvPr/>
        </p:nvSpPr>
        <p:spPr>
          <a:xfrm>
            <a:off x="1254055" y="969707"/>
            <a:ext cx="879184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 Narrow" panose="020B0606020202030204" pitchFamily="34" charset="0"/>
                <a:cs typeface="Arial" panose="020B0604020202020204" pitchFamily="34" charset="0"/>
              </a:rPr>
              <a:t>Pump 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0CBC272-2BE1-D450-40EA-2CD88217220E}"/>
              </a:ext>
            </a:extLst>
          </p:cNvPr>
          <p:cNvSpPr txBox="1"/>
          <p:nvPr/>
        </p:nvSpPr>
        <p:spPr>
          <a:xfrm>
            <a:off x="727730" y="3048000"/>
            <a:ext cx="879184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 Narrow" panose="020B0606020202030204" pitchFamily="34" charset="0"/>
                <a:cs typeface="Arial" panose="020B0604020202020204" pitchFamily="34" charset="0"/>
              </a:rPr>
              <a:t>Pump 2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36052B5-29B9-0E91-34C8-FD217C90A29D}"/>
              </a:ext>
            </a:extLst>
          </p:cNvPr>
          <p:cNvSpPr/>
          <p:nvPr/>
        </p:nvSpPr>
        <p:spPr>
          <a:xfrm>
            <a:off x="4165872" y="5233027"/>
            <a:ext cx="3187428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S1. Fabricate Collagen Hydrogel Tubes. </a:t>
            </a:r>
            <a:r>
              <a:rPr lang="en-US" sz="1000" dirty="0"/>
              <a:t>The setup for processing ColTubes, which includes three syringe pumps, the micro-extruder, the cooling box, a heating pad, and a HEPES buffer reservoir. To fabricate ColTubes, a cell solution at room temperature (RT), an ice-cold collagen solution (pH = 3.0), and a HEPES buffer (RT, pH = 7.4) are pumped into inlet 1, 2, and 3 of the micro-extruder, respectively, to form coaxial core-shell-sheath laminar flows that are extruded into a heated HEPES buffer (37°C, pH = 7.4). The shell collagen flow rapidly forms a hydrogel tube as a result of the combined pH neutralization and temperature increase.</a:t>
            </a:r>
          </a:p>
        </p:txBody>
      </p:sp>
    </p:spTree>
    <p:extLst>
      <p:ext uri="{BB962C8B-B14F-4D97-AF65-F5344CB8AC3E}">
        <p14:creationId xmlns:p14="http://schemas.microsoft.com/office/powerpoint/2010/main" val="293544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590fea8-b43e-4be5-abf1-9cc087fb0ca9">
      <Terms xmlns="http://schemas.microsoft.com/office/infopath/2007/PartnerControls"/>
    </lcf76f155ced4ddcb4097134ff3c332f>
    <TaxCatchAll xmlns="6de238ee-0c3b-46c4-ae48-b7b3be2bec5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AE2816E44124D4EAC50EE55289EDB1B" ma:contentTypeVersion="19" ma:contentTypeDescription="Create a new document." ma:contentTypeScope="" ma:versionID="0d68260364ff96cf945da7cbba6e4801">
  <xsd:schema xmlns:xsd="http://www.w3.org/2001/XMLSchema" xmlns:xs="http://www.w3.org/2001/XMLSchema" xmlns:p="http://schemas.microsoft.com/office/2006/metadata/properties" xmlns:ns2="e590fea8-b43e-4be5-abf1-9cc087fb0ca9" xmlns:ns3="6de238ee-0c3b-46c4-ae48-b7b3be2bec59" targetNamespace="http://schemas.microsoft.com/office/2006/metadata/properties" ma:root="true" ma:fieldsID="270c77a8eea479fa249bb5751f347554" ns2:_="" ns3:_="">
    <xsd:import namespace="e590fea8-b43e-4be5-abf1-9cc087fb0ca9"/>
    <xsd:import namespace="6de238ee-0c3b-46c4-ae48-b7b3be2bec5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Location" minOccurs="0"/>
                <xsd:element ref="ns2:MediaServiceOCR" minOccurs="0"/>
                <xsd:element ref="ns2:lcf76f155ced4ddcb4097134ff3c332f" minOccurs="0"/>
                <xsd:element ref="ns3:TaxCatchAll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90fea8-b43e-4be5-abf1-9cc087fb0c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28b28469-8996-4088-bd89-44d87d6385e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de238ee-0c3b-46c4-ae48-b7b3be2bec59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ff48ad4f-232c-44c2-aeae-7cfe56513bcc}" ma:internalName="TaxCatchAll" ma:showField="CatchAllData" ma:web="6de238ee-0c3b-46c4-ae48-b7b3be2bec5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0FBCF39-7A31-4726-AFD7-F40EA13BD54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C51631E-BA7B-4182-9244-2836C820E8ED}">
  <ds:schemaRefs>
    <ds:schemaRef ds:uri="http://purl.org/dc/terms/"/>
    <ds:schemaRef ds:uri="http://purl.org/dc/dcmitype/"/>
    <ds:schemaRef ds:uri="http://schemas.microsoft.com/office/2006/metadata/properties"/>
    <ds:schemaRef ds:uri="http://schemas.microsoft.com/office/infopath/2007/PartnerControls"/>
    <ds:schemaRef ds:uri="http://schemas.microsoft.com/office/2006/documentManagement/types"/>
    <ds:schemaRef ds:uri="http://www.w3.org/XML/1998/namespace"/>
    <ds:schemaRef ds:uri="e590fea8-b43e-4be5-abf1-9cc087fb0ca9"/>
    <ds:schemaRef ds:uri="http://schemas.openxmlformats.org/package/2006/metadata/core-properties"/>
    <ds:schemaRef ds:uri="6de238ee-0c3b-46c4-ae48-b7b3be2bec59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D701833F-E677-4CA7-BF48-B9F8BC2C403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590fea8-b43e-4be5-abf1-9cc087fb0ca9"/>
    <ds:schemaRef ds:uri="6de238ee-0c3b-46c4-ae48-b7b3be2bec5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7cf48d45-3ddb-4389-a9c1-c115526eb52e}" enabled="0" method="" siteId="{7cf48d45-3ddb-4389-a9c1-c115526eb52e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249</TotalTime>
  <Words>161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ang Li</dc:creator>
  <cp:lastModifiedBy>Wu, Xinran</cp:lastModifiedBy>
  <cp:revision>152</cp:revision>
  <cp:lastPrinted>2026-01-02T17:12:42Z</cp:lastPrinted>
  <dcterms:created xsi:type="dcterms:W3CDTF">2016-04-28T18:30:23Z</dcterms:created>
  <dcterms:modified xsi:type="dcterms:W3CDTF">2026-05-29T20:1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AE2816E44124D4EAC50EE55289EDB1B</vt:lpwstr>
  </property>
  <property fmtid="{D5CDD505-2E9C-101B-9397-08002B2CF9AE}" pid="3" name="MediaServiceImageTags">
    <vt:lpwstr/>
  </property>
</Properties>
</file>